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-1074" y="244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5CA1-1823-4D3F-8F0D-2F2749077231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275B4-57E3-4FDB-850B-40C45770A8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38086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5CA1-1823-4D3F-8F0D-2F2749077231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275B4-57E3-4FDB-850B-40C45770A8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73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5CA1-1823-4D3F-8F0D-2F2749077231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275B4-57E3-4FDB-850B-40C45770A8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72846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5CA1-1823-4D3F-8F0D-2F2749077231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275B4-57E3-4FDB-850B-40C45770A8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07367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5CA1-1823-4D3F-8F0D-2F2749077231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275B4-57E3-4FDB-850B-40C45770A8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02827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5CA1-1823-4D3F-8F0D-2F2749077231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275B4-57E3-4FDB-850B-40C45770A8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90372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5CA1-1823-4D3F-8F0D-2F2749077231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275B4-57E3-4FDB-850B-40C45770A8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06558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5CA1-1823-4D3F-8F0D-2F2749077231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275B4-57E3-4FDB-850B-40C45770A8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217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5CA1-1823-4D3F-8F0D-2F2749077231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275B4-57E3-4FDB-850B-40C45770A8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63585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5CA1-1823-4D3F-8F0D-2F2749077231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275B4-57E3-4FDB-850B-40C45770A8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80292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5CA1-1823-4D3F-8F0D-2F2749077231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275B4-57E3-4FDB-850B-40C45770A8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05906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475CA1-1823-4D3F-8F0D-2F2749077231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8275B4-57E3-4FDB-850B-40C45770A8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728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7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237" b="698"/>
          <a:stretch/>
        </p:blipFill>
        <p:spPr bwMode="auto">
          <a:xfrm>
            <a:off x="125668" y="4310475"/>
            <a:ext cx="6646607" cy="201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" t="-1482" r="35134" b="13868"/>
          <a:stretch/>
        </p:blipFill>
        <p:spPr bwMode="auto">
          <a:xfrm>
            <a:off x="67643" y="422563"/>
            <a:ext cx="2023609" cy="17658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2030626" y="605174"/>
            <a:ext cx="5974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itchFamily="34" charset="0"/>
                <a:cs typeface="Arial" pitchFamily="34" charset="0"/>
              </a:rPr>
              <a:t>Contro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030626" y="834186"/>
            <a:ext cx="9663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Phleo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 10</a:t>
            </a:r>
            <a:r>
              <a:rPr lang="el-GR" sz="800" b="1" dirty="0" smtClean="0">
                <a:latin typeface="Arial" pitchFamily="34" charset="0"/>
                <a:cs typeface="Arial" pitchFamily="34" charset="0"/>
              </a:rPr>
              <a:t>μ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g/ m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030626" y="1056231"/>
            <a:ext cx="11139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Phleo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+ 0.60M </a:t>
            </a:r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KC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030626" y="1271675"/>
            <a:ext cx="11139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Phleo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+ 0.30M </a:t>
            </a:r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KC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030626" y="1516724"/>
            <a:ext cx="11139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Phleo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+ 0.15M </a:t>
            </a:r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KC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030626" y="1732168"/>
            <a:ext cx="11139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Phleo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+ 0.07M </a:t>
            </a:r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KC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030625" y="1951199"/>
            <a:ext cx="11139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Phleo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+ 0.04M </a:t>
            </a:r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KC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62986" y="2188457"/>
            <a:ext cx="5974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wt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362053" y="2188457"/>
            <a:ext cx="5974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i="1" dirty="0" smtClean="0">
                <a:latin typeface="Arial" pitchFamily="34" charset="0"/>
                <a:cs typeface="Arial" pitchFamily="34" charset="0"/>
              </a:rPr>
              <a:t>rad24</a:t>
            </a:r>
            <a:r>
              <a:rPr lang="el-GR" sz="800" b="1" dirty="0" smtClean="0">
                <a:latin typeface="Arial" pitchFamily="34" charset="0"/>
                <a:cs typeface="Arial" pitchFamily="34" charset="0"/>
              </a:rPr>
              <a:t>Δ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0" y="-1"/>
            <a:ext cx="1219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sv-S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le</a:t>
            </a:r>
            <a:r>
              <a:rPr lang="sv-S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1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0" y="216644"/>
            <a:ext cx="2987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smtClean="0">
                <a:latin typeface="Arial" pitchFamily="34" charset="0"/>
                <a:cs typeface="Arial" pitchFamily="34" charset="0"/>
              </a:rPr>
              <a:t>A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8" name="Picture 2"/>
          <p:cNvPicPr>
            <a:picLocks noChangeAspect="1" noChangeArrowheads="1"/>
          </p:cNvPicPr>
          <p:nvPr/>
        </p:nvPicPr>
        <p:blipFill>
          <a:blip r:embed="rId4" cstate="print">
            <a:grayscl/>
            <a:lum bright="-9000"/>
          </a:blip>
          <a:srcRect/>
          <a:stretch>
            <a:fillRect/>
          </a:stretch>
        </p:blipFill>
        <p:spPr bwMode="auto">
          <a:xfrm>
            <a:off x="3060874" y="551876"/>
            <a:ext cx="1011804" cy="15945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9" name="AutoShape 149"/>
          <p:cNvSpPr>
            <a:spLocks noChangeArrowheads="1"/>
          </p:cNvSpPr>
          <p:nvPr/>
        </p:nvSpPr>
        <p:spPr bwMode="auto">
          <a:xfrm>
            <a:off x="3050375" y="426583"/>
            <a:ext cx="1022303" cy="87060"/>
          </a:xfrm>
          <a:prstGeom prst="rtTriangle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sv-SE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034577" y="835046"/>
            <a:ext cx="9659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>
                <a:latin typeface="Arial" panose="020B0604020202020204" pitchFamily="34" charset="0"/>
                <a:cs typeface="Arial" pitchFamily="34" charset="0"/>
              </a:rPr>
              <a:t>Phleo</a:t>
            </a:r>
            <a:r>
              <a:rPr lang="sv-SE" sz="800" b="1" dirty="0">
                <a:latin typeface="Arial" panose="020B0604020202020204" pitchFamily="34" charset="0"/>
                <a:cs typeface="Arial" pitchFamily="34" charset="0"/>
              </a:rPr>
              <a:t> 1µg/ ml</a:t>
            </a:r>
            <a:endParaRPr lang="sv-SE" sz="800" b="1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034577" y="560845"/>
            <a:ext cx="6273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Contro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034577" y="1120796"/>
            <a:ext cx="9659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Phleo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 2.5µg/ ml</a:t>
            </a:r>
            <a:endParaRPr lang="sv-SE" sz="800" b="1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034577" y="1383865"/>
            <a:ext cx="9659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Phleo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 5µg/ ml</a:t>
            </a:r>
            <a:endParaRPr lang="sv-SE" sz="800" b="1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034577" y="1654196"/>
            <a:ext cx="10421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Phleo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 7.5µg/ ml</a:t>
            </a:r>
            <a:endParaRPr lang="sv-SE" sz="800" b="1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034577" y="1939946"/>
            <a:ext cx="9659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Phleo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 10µg/ ml</a:t>
            </a:r>
            <a:endParaRPr lang="sv-SE" sz="800" b="1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911515" y="216644"/>
            <a:ext cx="2987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smtClean="0">
                <a:latin typeface="Arial" pitchFamily="34" charset="0"/>
                <a:cs typeface="Arial" pitchFamily="34" charset="0"/>
              </a:rPr>
              <a:t>B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7" name="Picture 2"/>
          <p:cNvPicPr>
            <a:picLocks noChangeAspect="1" noChangeArrowheads="1"/>
          </p:cNvPicPr>
          <p:nvPr/>
        </p:nvPicPr>
        <p:blipFill>
          <a:blip r:embed="rId5" cstate="print">
            <a:grayscl/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5000" contrast="5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643" y="2839648"/>
            <a:ext cx="973531" cy="9296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8" name="AutoShape 149"/>
          <p:cNvSpPr>
            <a:spLocks noChangeArrowheads="1"/>
          </p:cNvSpPr>
          <p:nvPr/>
        </p:nvSpPr>
        <p:spPr bwMode="auto">
          <a:xfrm>
            <a:off x="67643" y="2719147"/>
            <a:ext cx="973531" cy="82517"/>
          </a:xfrm>
          <a:prstGeom prst="rtTriangle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sv-SE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012264" y="2901758"/>
            <a:ext cx="6273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Contro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012264" y="3117202"/>
            <a:ext cx="8595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Hygro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 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5µg/ml</a:t>
            </a:r>
            <a:endParaRPr lang="sv-SE" sz="800" b="1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1012264" y="3332646"/>
            <a:ext cx="9730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Hygro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 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10µg/ml</a:t>
            </a:r>
            <a:endParaRPr lang="sv-SE" sz="800" b="1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1012264" y="3573723"/>
            <a:ext cx="9441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Hygro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 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25µg/ml</a:t>
            </a:r>
            <a:endParaRPr lang="sv-SE" sz="800" b="1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AutoShape 149"/>
          <p:cNvSpPr>
            <a:spLocks noChangeArrowheads="1"/>
          </p:cNvSpPr>
          <p:nvPr/>
        </p:nvSpPr>
        <p:spPr bwMode="auto">
          <a:xfrm>
            <a:off x="4916490" y="426583"/>
            <a:ext cx="1027866" cy="92776"/>
          </a:xfrm>
          <a:prstGeom prst="rtTriangle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sv-SE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5904945" y="560845"/>
            <a:ext cx="762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Contro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5904945" y="835046"/>
            <a:ext cx="10845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G418 5 µg/ m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5904945" y="1120796"/>
            <a:ext cx="10845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G418 10 µg/ m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5904945" y="1383865"/>
            <a:ext cx="10845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G418 25 µg/ m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5904945" y="1654196"/>
            <a:ext cx="11797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G418 37.5 µg/ m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5904945" y="1939946"/>
            <a:ext cx="10845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G418 50 µg/ m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0" name="Picture 4"/>
          <p:cNvPicPr>
            <a:picLocks noChangeAspect="1" noChangeArrowheads="1"/>
          </p:cNvPicPr>
          <p:nvPr/>
        </p:nvPicPr>
        <p:blipFill>
          <a:blip r:embed="rId7" cstate="print">
            <a:grayscl/>
            <a:lum bright="-28000" contrast="18000"/>
          </a:blip>
          <a:srcRect/>
          <a:stretch>
            <a:fillRect/>
          </a:stretch>
        </p:blipFill>
        <p:spPr bwMode="auto">
          <a:xfrm>
            <a:off x="4916489" y="551876"/>
            <a:ext cx="1027866" cy="15945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" name="Picture 3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013" b="642"/>
          <a:stretch/>
        </p:blipFill>
        <p:spPr bwMode="auto">
          <a:xfrm>
            <a:off x="153082" y="6696000"/>
            <a:ext cx="6622319" cy="223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2" name="Picture 3"/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" t="13633" r="50517" b="1197"/>
          <a:stretch/>
        </p:blipFill>
        <p:spPr bwMode="auto">
          <a:xfrm>
            <a:off x="2015630" y="2849173"/>
            <a:ext cx="1008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4" name="TextBox 43"/>
          <p:cNvSpPr txBox="1"/>
          <p:nvPr/>
        </p:nvSpPr>
        <p:spPr>
          <a:xfrm>
            <a:off x="4730790" y="216644"/>
            <a:ext cx="2987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smtClean="0">
                <a:latin typeface="Arial" pitchFamily="34" charset="0"/>
                <a:cs typeface="Arial" pitchFamily="34" charset="0"/>
              </a:rPr>
              <a:t>C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0" y="2455019"/>
            <a:ext cx="2987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smtClean="0">
                <a:latin typeface="Arial" pitchFamily="34" charset="0"/>
                <a:cs typeface="Arial" pitchFamily="34" charset="0"/>
              </a:rPr>
              <a:t>D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1844715" y="2502644"/>
            <a:ext cx="2987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smtClean="0">
                <a:latin typeface="Arial" pitchFamily="34" charset="0"/>
                <a:cs typeface="Arial" pitchFamily="34" charset="0"/>
              </a:rPr>
              <a:t>E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0" y="3940359"/>
            <a:ext cx="2987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smtClean="0">
                <a:latin typeface="Arial" pitchFamily="34" charset="0"/>
                <a:cs typeface="Arial" pitchFamily="34" charset="0"/>
              </a:rPr>
              <a:t>F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0" y="6439831"/>
            <a:ext cx="2987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smtClean="0">
                <a:latin typeface="Arial" pitchFamily="34" charset="0"/>
                <a:cs typeface="Arial" pitchFamily="34" charset="0"/>
              </a:rPr>
              <a:t>G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3020194" y="2855615"/>
            <a:ext cx="5974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itchFamily="34" charset="0"/>
                <a:cs typeface="Arial" pitchFamily="34" charset="0"/>
              </a:rPr>
              <a:t>Contro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AutoShape 149"/>
          <p:cNvSpPr>
            <a:spLocks noChangeArrowheads="1"/>
          </p:cNvSpPr>
          <p:nvPr/>
        </p:nvSpPr>
        <p:spPr bwMode="auto">
          <a:xfrm>
            <a:off x="2017415" y="2728672"/>
            <a:ext cx="973531" cy="82517"/>
          </a:xfrm>
          <a:prstGeom prst="rtTriangle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sv-SE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3021226" y="3101136"/>
            <a:ext cx="9663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Phleo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 10</a:t>
            </a:r>
            <a:r>
              <a:rPr lang="el-GR" sz="800" b="1" dirty="0" smtClean="0">
                <a:latin typeface="Arial" pitchFamily="34" charset="0"/>
                <a:cs typeface="Arial" pitchFamily="34" charset="0"/>
              </a:rPr>
              <a:t>μ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g/m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3002175" y="3348786"/>
            <a:ext cx="15126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itchFamily="34" charset="0"/>
                <a:cs typeface="Arial" pitchFamily="34" charset="0"/>
              </a:rPr>
              <a:t>0.6M </a:t>
            </a:r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KCl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&gt;</a:t>
            </a:r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Phleo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 10</a:t>
            </a:r>
            <a:r>
              <a:rPr lang="el-GR" sz="800" b="1" dirty="0" smtClean="0">
                <a:latin typeface="Arial" pitchFamily="34" charset="0"/>
                <a:cs typeface="Arial" pitchFamily="34" charset="0"/>
              </a:rPr>
              <a:t>μ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g/m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506626" y="4100600"/>
            <a:ext cx="5974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itchFamily="34" charset="0"/>
                <a:cs typeface="Arial" pitchFamily="34" charset="0"/>
              </a:rPr>
              <a:t>Contro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1611526" y="4100600"/>
            <a:ext cx="9663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Phleo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 10</a:t>
            </a:r>
            <a:r>
              <a:rPr lang="el-GR" sz="800" b="1" dirty="0" smtClean="0">
                <a:latin typeface="Arial" pitchFamily="34" charset="0"/>
                <a:cs typeface="Arial" pitchFamily="34" charset="0"/>
              </a:rPr>
              <a:t>μ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g/m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5535826" y="4100600"/>
            <a:ext cx="11139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Phleo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+ 0.60M </a:t>
            </a:r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KC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4211851" y="4100600"/>
            <a:ext cx="11139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Phleo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+ 0.30M </a:t>
            </a:r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KC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2859301" y="4100600"/>
            <a:ext cx="11139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Phleo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+ 0.15M </a:t>
            </a:r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KC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506626" y="6481850"/>
            <a:ext cx="5974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smtClean="0">
                <a:latin typeface="Arial" pitchFamily="34" charset="0"/>
                <a:cs typeface="Arial" pitchFamily="34" charset="0"/>
              </a:rPr>
              <a:t>Contro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1678201" y="6481850"/>
            <a:ext cx="9411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smtClean="0">
                <a:latin typeface="Arial" pitchFamily="34" charset="0"/>
                <a:cs typeface="Arial" pitchFamily="34" charset="0"/>
              </a:rPr>
              <a:t>Lat B 10</a:t>
            </a:r>
            <a:r>
              <a:rPr lang="el-GR" sz="800" b="1" dirty="0" smtClean="0">
                <a:latin typeface="Arial" pitchFamily="34" charset="0"/>
                <a:cs typeface="Arial" pitchFamily="34" charset="0"/>
              </a:rPr>
              <a:t>μ</a:t>
            </a:r>
            <a:r>
              <a:rPr lang="sv-SE" sz="800" b="1" dirty="0">
                <a:latin typeface="Arial" pitchFamily="34" charset="0"/>
                <a:cs typeface="Arial" pitchFamily="34" charset="0"/>
              </a:rPr>
              <a:t>M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2925975" y="6481850"/>
            <a:ext cx="10459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smtClean="0">
                <a:latin typeface="Arial" pitchFamily="34" charset="0"/>
                <a:cs typeface="Arial" pitchFamily="34" charset="0"/>
              </a:rPr>
              <a:t>Lat B+ 0.6M </a:t>
            </a:r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KC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4297576" y="6481850"/>
            <a:ext cx="9411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smtClean="0">
                <a:latin typeface="Arial" pitchFamily="34" charset="0"/>
                <a:cs typeface="Arial" pitchFamily="34" charset="0"/>
              </a:rPr>
              <a:t>MBC </a:t>
            </a:r>
            <a:r>
              <a:rPr lang="sv-SE" sz="800" b="1" dirty="0">
                <a:latin typeface="Arial" pitchFamily="34" charset="0"/>
                <a:cs typeface="Arial" pitchFamily="34" charset="0"/>
              </a:rPr>
              <a:t>5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0</a:t>
            </a:r>
            <a:r>
              <a:rPr lang="el-GR" sz="800" b="1" dirty="0" smtClean="0">
                <a:latin typeface="Arial" pitchFamily="34" charset="0"/>
                <a:cs typeface="Arial" pitchFamily="34" charset="0"/>
              </a:rPr>
              <a:t>μ</a:t>
            </a:r>
            <a:r>
              <a:rPr lang="sv-SE" sz="800" b="1" smtClean="0">
                <a:latin typeface="Arial" pitchFamily="34" charset="0"/>
                <a:cs typeface="Arial" pitchFamily="34" charset="0"/>
              </a:rPr>
              <a:t>g/m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5612026" y="6481850"/>
            <a:ext cx="9411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smtClean="0">
                <a:latin typeface="Arial" pitchFamily="34" charset="0"/>
                <a:cs typeface="Arial" pitchFamily="34" charset="0"/>
              </a:rPr>
              <a:t>MBC+ 0.6M </a:t>
            </a:r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KC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134119" y="4331990"/>
            <a:ext cx="5974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i="1" dirty="0" smtClean="0">
                <a:latin typeface="Arial" pitchFamily="34" charset="0"/>
                <a:cs typeface="Arial" pitchFamily="34" charset="0"/>
              </a:rPr>
              <a:t>rad24</a:t>
            </a:r>
            <a:r>
              <a:rPr lang="el-GR" sz="800" b="1" dirty="0" smtClean="0">
                <a:latin typeface="Arial" pitchFamily="34" charset="0"/>
                <a:cs typeface="Arial" pitchFamily="34" charset="0"/>
              </a:rPr>
              <a:t>Δ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71881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0</TotalTime>
  <Words>142</Words>
  <Application>Microsoft Office PowerPoint</Application>
  <PresentationFormat>On-screen Show (4:3)</PresentationFormat>
  <Paragraphs>4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Gothenburg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Patrick Alao</dc:creator>
  <cp:lastModifiedBy>John Patrick Alao</cp:lastModifiedBy>
  <cp:revision>9</cp:revision>
  <dcterms:created xsi:type="dcterms:W3CDTF">2014-10-05T19:59:26Z</dcterms:created>
  <dcterms:modified xsi:type="dcterms:W3CDTF">2014-11-22T20:35:55Z</dcterms:modified>
</cp:coreProperties>
</file>